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4"/>
  </p:notesMasterIdLst>
  <p:sldIdLst>
    <p:sldId id="256" r:id="rId2"/>
    <p:sldId id="288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583"/>
    <p:restoredTop sz="94679"/>
  </p:normalViewPr>
  <p:slideViewPr>
    <p:cSldViewPr snapToGrid="0" snapToObjects="1">
      <p:cViewPr>
        <p:scale>
          <a:sx n="196" d="100"/>
          <a:sy n="196" d="100"/>
        </p:scale>
        <p:origin x="2432" y="-64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B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D27F81-690C-4F4C-B161-BAC4992AEB48}" type="datetimeFigureOut">
              <a:rPr lang="en-BE" smtClean="0"/>
              <a:t>17/12/2020</a:t>
            </a:fld>
            <a:endParaRPr lang="en-B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B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C7D4072-1BCC-6942-96E6-0D8AE50901AD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27288441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31D5B1A-C0B0-40D2-BE5F-92D45F8D0189}" type="slidenum">
              <a:rPr lang="nl-NL" smtClean="0"/>
              <a:t>2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9984181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09D23-EE92-0249-AADA-8D3F86C33993}" type="datetimeFigureOut">
              <a:rPr lang="en-BE" smtClean="0"/>
              <a:t>17/12/2020</a:t>
            </a:fld>
            <a:endParaRPr lang="en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29ADA-2640-CD48-A830-4E8F7D39A375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5328597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09D23-EE92-0249-AADA-8D3F86C33993}" type="datetimeFigureOut">
              <a:rPr lang="en-BE" smtClean="0"/>
              <a:t>17/12/2020</a:t>
            </a:fld>
            <a:endParaRPr lang="en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29ADA-2640-CD48-A830-4E8F7D39A375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41354446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09D23-EE92-0249-AADA-8D3F86C33993}" type="datetimeFigureOut">
              <a:rPr lang="en-BE" smtClean="0"/>
              <a:t>17/12/2020</a:t>
            </a:fld>
            <a:endParaRPr lang="en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29ADA-2640-CD48-A830-4E8F7D39A375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14741906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09D23-EE92-0249-AADA-8D3F86C33993}" type="datetimeFigureOut">
              <a:rPr lang="en-BE" smtClean="0"/>
              <a:t>17/12/2020</a:t>
            </a:fld>
            <a:endParaRPr lang="en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29ADA-2640-CD48-A830-4E8F7D39A375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8853069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09D23-EE92-0249-AADA-8D3F86C33993}" type="datetimeFigureOut">
              <a:rPr lang="en-BE" smtClean="0"/>
              <a:t>17/12/2020</a:t>
            </a:fld>
            <a:endParaRPr lang="en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29ADA-2640-CD48-A830-4E8F7D39A375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5144162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09D23-EE92-0249-AADA-8D3F86C33993}" type="datetimeFigureOut">
              <a:rPr lang="en-BE" smtClean="0"/>
              <a:t>17/12/2020</a:t>
            </a:fld>
            <a:endParaRPr lang="en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29ADA-2640-CD48-A830-4E8F7D39A375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21684421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09D23-EE92-0249-AADA-8D3F86C33993}" type="datetimeFigureOut">
              <a:rPr lang="en-BE" smtClean="0"/>
              <a:t>17/12/2020</a:t>
            </a:fld>
            <a:endParaRPr lang="en-B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29ADA-2640-CD48-A830-4E8F7D39A375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28292314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09D23-EE92-0249-AADA-8D3F86C33993}" type="datetimeFigureOut">
              <a:rPr lang="en-BE" smtClean="0"/>
              <a:t>17/12/2020</a:t>
            </a:fld>
            <a:endParaRPr lang="en-B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29ADA-2640-CD48-A830-4E8F7D39A375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32379090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09D23-EE92-0249-AADA-8D3F86C33993}" type="datetimeFigureOut">
              <a:rPr lang="en-BE" smtClean="0"/>
              <a:t>17/12/2020</a:t>
            </a:fld>
            <a:endParaRPr lang="en-B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29ADA-2640-CD48-A830-4E8F7D39A375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14156258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09D23-EE92-0249-AADA-8D3F86C33993}" type="datetimeFigureOut">
              <a:rPr lang="en-BE" smtClean="0"/>
              <a:t>17/12/2020</a:t>
            </a:fld>
            <a:endParaRPr lang="en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29ADA-2640-CD48-A830-4E8F7D39A375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12386676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09D23-EE92-0249-AADA-8D3F86C33993}" type="datetimeFigureOut">
              <a:rPr lang="en-BE" smtClean="0"/>
              <a:t>17/12/2020</a:t>
            </a:fld>
            <a:endParaRPr lang="en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29ADA-2640-CD48-A830-4E8F7D39A375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26072358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409D23-EE92-0249-AADA-8D3F86C33993}" type="datetimeFigureOut">
              <a:rPr lang="en-BE" smtClean="0"/>
              <a:t>17/12/2020</a:t>
            </a:fld>
            <a:endParaRPr lang="en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629ADA-2640-CD48-A830-4E8F7D39A375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11072694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81B14E71-AE09-2B4A-A854-CD71FACA178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5150" y="857250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BE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B394237-208F-C24D-A4D4-4C8D6FE997AC}"/>
              </a:ext>
            </a:extLst>
          </p:cNvPr>
          <p:cNvSpPr txBox="1"/>
          <p:nvPr/>
        </p:nvSpPr>
        <p:spPr>
          <a:xfrm>
            <a:off x="461168" y="6076950"/>
            <a:ext cx="5935663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 The  XPO1</a:t>
            </a:r>
            <a:r>
              <a:rPr lang="en-US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IL2RA</a:t>
            </a:r>
            <a:r>
              <a:rPr lang="en-US" sz="9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is unique to ATL patients, being absent in healthy control CD4+ cells and in B-cell Acute Lymphoblastic Leukemia and T-cell Acute Lymphoblastic Leukemia.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BE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XPO1 and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IL2RA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transcript levels were quantified in purified CD4+ cells from healthy controls (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ImmuCo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, quantified as RMA) and analyzed by Spearman correlation. (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XPO1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IL2RA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transcript levels were quantified in primary cells from ATL patients from the Japanese cohort by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RNAseq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(TPM: transcripts per million) and analyzed by Spearman correlation. (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XPO1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IL2RA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transcript levels were quantified in primary cells from patients with B-cell Acute Lymphocytic Leukemia (B-ALL,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ImmuCo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, RMA) and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analysed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by Spearman correlation.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 XPO1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IL2RA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transcript levels were quantified in primary cells from patients with T-cell Acute Lymphocytic Leukemia (T-ALL,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ImmuCo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, RMA) and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analysed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by Spearman correlation.</a:t>
            </a:r>
          </a:p>
          <a:p>
            <a:pPr algn="just"/>
            <a:endParaRPr lang="en-BE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ppl. Reference: </a:t>
            </a:r>
            <a:endParaRPr lang="en-BE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. Z. Wang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 et al.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ImmuCo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: a database of gene co-expression in immune cells.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Nucleic Acids Res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, D1133-D1139 (2015).</a:t>
            </a:r>
            <a:endParaRPr lang="en-BE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B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8">
            <a:extLst>
              <a:ext uri="{FF2B5EF4-FFF2-40B4-BE49-F238E27FC236}">
                <a16:creationId xmlns:a16="http://schemas.microsoft.com/office/drawing/2014/main" id="{34DA1026-3FDA-854F-8981-8E408A665121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BE"/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581FB30D-F130-0842-99E5-7F2E1EC5977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70473966"/>
              </p:ext>
            </p:extLst>
          </p:nvPr>
        </p:nvGraphicFramePr>
        <p:xfrm>
          <a:off x="565150" y="502326"/>
          <a:ext cx="5740400" cy="5219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6" r:id="rId3" imgW="6642100" imgH="6045200" progId="Prism9.Document">
                  <p:embed/>
                </p:oleObj>
              </mc:Choice>
              <mc:Fallback>
                <p:oleObj r:id="rId3" imgW="6642100" imgH="6045200" progId="Prism9.Document">
                  <p:embed/>
                  <p:pic>
                    <p:nvPicPr>
                      <p:cNvPr id="0" name="Object 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65150" y="502326"/>
                        <a:ext cx="5740400" cy="52197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7248491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2" name="Content Placeholder 2">
            <a:extLst>
              <a:ext uri="{FF2B5EF4-FFF2-40B4-BE49-F238E27FC236}">
                <a16:creationId xmlns:a16="http://schemas.microsoft.com/office/drawing/2014/main" id="{3921E8A8-DDA4-474C-8B19-B14577584FC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85153" y="7489984"/>
            <a:ext cx="6554598" cy="1985142"/>
          </a:xfrm>
        </p:spPr>
        <p:txBody>
          <a:bodyPr>
            <a:noAutofit/>
          </a:bodyPr>
          <a:lstStyle/>
          <a:p>
            <a:pPr marL="0" indent="0" algn="just">
              <a:lnSpc>
                <a:spcPct val="100000"/>
              </a:lnSpc>
              <a:buNone/>
            </a:pP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 Treatment with </a:t>
            </a:r>
            <a:r>
              <a:rPr 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selinexor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(KPT-330) results in nuclear accumulation of p53. </a:t>
            </a:r>
          </a:p>
          <a:p>
            <a:pPr marL="0" indent="0" algn="just">
              <a:lnSpc>
                <a:spcPct val="100000"/>
              </a:lnSpc>
              <a:buNone/>
            </a:pP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Immunofluorescence analysis for p53 and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IκB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in MT-2 and MT-4 cells 16h after incubation with DMSO or 1µM KPT-330.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Simple western analysis for p53 was performed on nuclear extracts at different time points of incubation with KPT-330. The graphs show means of p53 expression relative to actin expression with SEM (n=3). Data are normalized to 1µM KPT-330 within each separate experiment (set to 1). RM one-way ANOVA, with the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Geisser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Greenhouse correction was performed. *= p &lt;0.0332; **= p &lt;0.0021, ***= p &lt;0.0002 and ****= p &lt;0.0001.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 Simple Western analysis for p21 and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Bax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was performed on whole cell lysates after overnight incubation of MT-2 or MT-4 cells with different concentrations of KPT-330. The graphs show means of p21 and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Bax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expression relative to Vinculin expression with SEM (n=4). Data are normalized to 1µM KPT330 within each separate experiment (set to 1). RM one-way ANOVA, with the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Geisser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Greenhouse correction was performed. *= p &lt;0.0332; **= p &lt;0.0021, ***= p &lt;0.0002 and ****= p &lt;0.0001.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(D)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T-2 or MT-4 cells were incubated overnight with DMSO or KPT-330 in absence or presence of the caspase inhibitor Q-VD-OPH. Whole cell lysates were analyzed for PARP and Caspase-3 cleavage by Simple Western.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A representative Simple Western of MT-2 and MT-4 cells for XPO1 and GAPDH after an overnight treatment with KPT-330. Graphs show means of XPO1 expression with SEM (n=4) in MT-2 and MT-4 cells relative to GAPDH expression. Data are normalized to DMSO within each separate experiment (set to 1). RM one-way ANOVA, with the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Geisser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Greenhouse correction was performed. *= p &lt;0.0332; **= p &lt;0.0021, ***= p &lt;0.0002 and ****= p &lt;0.0001.</a:t>
            </a:r>
            <a:r>
              <a:rPr lang="en-BE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D88E7E0-C60B-4643-98B2-A662D75DE15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2607" y="3100150"/>
            <a:ext cx="3294260" cy="1820789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6CEE0863-7CFA-6B45-9931-F6D07F281BE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67561" y="87532"/>
            <a:ext cx="5123520" cy="278519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81A194D-F7AC-6348-ACDC-4E9ADADE09F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00383" y="3014656"/>
            <a:ext cx="2777598" cy="2160354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52CD3362-0AB9-DE46-9845-755C623CC21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85745" y="5374369"/>
            <a:ext cx="1740050" cy="2026387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7501EAFA-8096-DD48-85C2-3A49AB13774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45883" y="5256479"/>
            <a:ext cx="2898317" cy="19890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598706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5</TotalTime>
  <Words>548</Words>
  <Application>Microsoft Macintosh PowerPoint</Application>
  <PresentationFormat>A4 Paper (210x297 mm)</PresentationFormat>
  <Paragraphs>8</Paragraphs>
  <Slides>2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rism9.Document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rk Daelemans</dc:creator>
  <cp:lastModifiedBy>Dirk Daelemans</cp:lastModifiedBy>
  <cp:revision>12</cp:revision>
  <dcterms:created xsi:type="dcterms:W3CDTF">2020-11-27T14:32:35Z</dcterms:created>
  <dcterms:modified xsi:type="dcterms:W3CDTF">2020-12-17T10:49:54Z</dcterms:modified>
</cp:coreProperties>
</file>